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4" d="100"/>
          <a:sy n="44" d="100"/>
        </p:scale>
        <p:origin x="223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E8DC8D-553E-4011-9D36-8EDE49C24C37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4C553C-3C58-445E-8FDD-E11EFBE10C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10635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02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015" algn="l" defTabSz="91402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029" algn="l" defTabSz="91402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044" algn="l" defTabSz="91402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057" algn="l" defTabSz="91402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072" algn="l" defTabSz="91402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086" algn="l" defTabSz="91402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101" algn="l" defTabSz="91402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6114" algn="l" defTabSz="91402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4C553C-3C58-445E-8FDD-E11EFBE10C09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59923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5F1F8-EB5A-47AD-9E94-F6CB90206836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AEF70-5754-41C6-8A63-98B61FE481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0929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5F1F8-EB5A-47AD-9E94-F6CB90206836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AEF70-5754-41C6-8A63-98B61FE481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4228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5F1F8-EB5A-47AD-9E94-F6CB90206836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AEF70-5754-41C6-8A63-98B61FE481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4623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5F1F8-EB5A-47AD-9E94-F6CB90206836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AEF70-5754-41C6-8A63-98B61FE481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6606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5F1F8-EB5A-47AD-9E94-F6CB90206836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AEF70-5754-41C6-8A63-98B61FE481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5974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5F1F8-EB5A-47AD-9E94-F6CB90206836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AEF70-5754-41C6-8A63-98B61FE481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7011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5F1F8-EB5A-47AD-9E94-F6CB90206836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AEF70-5754-41C6-8A63-98B61FE481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93744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5F1F8-EB5A-47AD-9E94-F6CB90206836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AEF70-5754-41C6-8A63-98B61FE481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37587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5F1F8-EB5A-47AD-9E94-F6CB90206836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AEF70-5754-41C6-8A63-98B61FE481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5936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5F1F8-EB5A-47AD-9E94-F6CB90206836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AEF70-5754-41C6-8A63-98B61FE481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10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5F1F8-EB5A-47AD-9E94-F6CB90206836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AEF70-5754-41C6-8A63-98B61FE481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9777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05F1F8-EB5A-47AD-9E94-F6CB90206836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AAEF70-5754-41C6-8A63-98B61FE481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7385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03C0A20-D943-41E7-BAA8-EE15B7A43EB1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334" y="328450"/>
            <a:ext cx="6351332" cy="8431976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7768E1DF-C597-4A0E-B689-EF00FA69FB3A}"/>
              </a:ext>
            </a:extLst>
          </p:cNvPr>
          <p:cNvSpPr/>
          <p:nvPr/>
        </p:nvSpPr>
        <p:spPr>
          <a:xfrm>
            <a:off x="253333" y="8912317"/>
            <a:ext cx="651063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kern="1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. S3 </a:t>
            </a:r>
            <a:r>
              <a:rPr lang="en-US" altLang="zh-CN" sz="1400" kern="1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ultiple-sequence alignment of </a:t>
            </a:r>
            <a:r>
              <a:rPr lang="en-US" altLang="zh-CN" sz="1400" i="1" kern="1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jNR-L</a:t>
            </a:r>
            <a:r>
              <a:rPr lang="en-US" altLang="zh-CN" sz="1400" kern="1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DSs from strains LDF01♀, LDF01♂, L049♀, and L060♂. F: ♀; M: ♂.</a:t>
            </a:r>
            <a:endParaRPr lang="zh-CN" altLang="zh-CN" sz="1400" kern="10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3468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33</Words>
  <Application>Microsoft Office PowerPoint</Application>
  <PresentationFormat>A4 纸张(210x297 毫米)</PresentationFormat>
  <Paragraphs>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Lenovo</cp:lastModifiedBy>
  <cp:revision>3</cp:revision>
  <dcterms:created xsi:type="dcterms:W3CDTF">2023-01-05T08:59:08Z</dcterms:created>
  <dcterms:modified xsi:type="dcterms:W3CDTF">2023-01-05T14:16:05Z</dcterms:modified>
</cp:coreProperties>
</file>